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8A4499-EA33-4193-A16B-20F63A74204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sldImg"/>
          </p:nvPr>
        </p:nvSpPr>
        <p:spPr>
          <a:xfrm>
            <a:off x="1128600" y="703440"/>
            <a:ext cx="4595760" cy="3446280"/>
          </a:xfrm>
          <a:prstGeom prst="rect">
            <a:avLst/>
          </a:prstGeom>
          <a:ln w="0">
            <a:noFill/>
          </a:ln>
        </p:spPr>
      </p:sp>
      <p:sp>
        <p:nvSpPr>
          <p:cNvPr id="138" name="PlaceHolder 2"/>
          <p:cNvSpPr>
            <a:spLocks noGrp="1"/>
          </p:cNvSpPr>
          <p:nvPr>
            <p:ph type="body"/>
          </p:nvPr>
        </p:nvSpPr>
        <p:spPr>
          <a:xfrm>
            <a:off x="921960" y="4361040"/>
            <a:ext cx="5000760" cy="40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ell cycle: CDKn1b= p27Kip down 4H, cyclin D3, cyclin-dep kin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ai2= snail homolog 2: transcriptional repressor: anti-apototic, involved in EMT;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4F864-0B77-463D-8FCB-270A1A354C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0C70B-646F-42CF-B5FC-29D3EE518B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EBB67-FD6F-4BC9-B68B-AB684C8546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8BF8E-3FEB-452E-80F4-79FF86A9D2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49FAA-93C1-49A2-9859-7148847286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90A793-0D23-49CD-9A04-C777C8C7BF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B113E-957B-4C55-8A10-88DBE0EE1C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F9BF1-BFC3-4AB0-A9F6-995A3F4603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A9B52-DC52-48DC-9ADC-C61D33BEFA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113DD-8CB5-455C-B023-32E4CC7C76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D8204-CB99-4244-ACB2-9C86B2EAED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EE082-A927-44F4-A4EA-E697530AC0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420B65-FC24-4713-985D-E2BB8E7FAFD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5.png"/><Relationship Id="rId11" Type="http://schemas.openxmlformats.org/officeDocument/2006/relationships/image" Target="../media/image5.png"/><Relationship Id="rId12" Type="http://schemas.openxmlformats.org/officeDocument/2006/relationships/image" Target="../media/image5.pn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830520" y="3124080"/>
            <a:ext cx="183600" cy="51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25400" y="1996920"/>
            <a:ext cx="457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rcRect l="0" t="58857" r="0" b="1582"/>
          <a:stretch/>
        </p:blipFill>
        <p:spPr>
          <a:xfrm>
            <a:off x="2209680" y="952560"/>
            <a:ext cx="2133720" cy="4903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2"/>
          <a:srcRect l="0" t="37557" r="0" b="0"/>
          <a:stretch/>
        </p:blipFill>
        <p:spPr>
          <a:xfrm>
            <a:off x="2209680" y="2806560"/>
            <a:ext cx="2133720" cy="76212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2286000" y="1498680"/>
            <a:ext cx="2666880" cy="100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cl2, Ccl7, Pai2, Il1Rl1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Dusp6, Eps8, Ngef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Itga6, Cd44, F3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Mmp3, Hmga1</a:t>
            </a:r>
            <a:r>
              <a:rPr b="0" lang="nl-NL" sz="1200" spc="-1" strike="noStrike" u="sng">
                <a:solidFill>
                  <a:srgbClr val="000000"/>
                </a:solidFill>
                <a:uFillTx/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280960" y="3578400"/>
            <a:ext cx="1969560" cy="100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dam19, Timp1, Os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Inhba, Sphk1, Wisp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av1, Cav2, Nfkbie, Ltga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"/>
          <p:cNvGrpSpPr/>
          <p:nvPr/>
        </p:nvGrpSpPr>
        <p:grpSpPr>
          <a:xfrm>
            <a:off x="166680" y="974880"/>
            <a:ext cx="2003400" cy="1742760"/>
            <a:chOff x="166680" y="974880"/>
            <a:chExt cx="2003400" cy="1742760"/>
          </a:xfrm>
        </p:grpSpPr>
        <p:grpSp>
          <p:nvGrpSpPr>
            <p:cNvPr id="55" name=""/>
            <p:cNvGrpSpPr/>
            <p:nvPr/>
          </p:nvGrpSpPr>
          <p:grpSpPr>
            <a:xfrm>
              <a:off x="166680" y="974880"/>
              <a:ext cx="2003400" cy="1742760"/>
              <a:chOff x="166680" y="974880"/>
              <a:chExt cx="2003400" cy="1742760"/>
            </a:xfrm>
          </p:grpSpPr>
          <p:pic>
            <p:nvPicPr>
              <p:cNvPr id="56" name="" descr=""/>
              <p:cNvPicPr/>
              <p:nvPr/>
            </p:nvPicPr>
            <p:blipFill>
              <a:blip r:embed="rId3"/>
              <a:srcRect l="50636" t="1314" r="25519" b="70452"/>
              <a:stretch/>
            </p:blipFill>
            <p:spPr>
              <a:xfrm>
                <a:off x="443160" y="974880"/>
                <a:ext cx="1726920" cy="1742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7" name=""/>
              <p:cNvSpPr/>
              <p:nvPr/>
            </p:nvSpPr>
            <p:spPr>
              <a:xfrm>
                <a:off x="1131840" y="1790640"/>
                <a:ext cx="51912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4-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1285920" y="1485720"/>
                <a:ext cx="154080" cy="304560"/>
              </a:xfrm>
              <a:prstGeom prst="upArrow">
                <a:avLst>
                  <a:gd name="adj1" fmla="val 50000"/>
                  <a:gd name="adj2" fmla="val 49416"/>
                </a:avLst>
              </a:prstGeom>
              <a:solidFill>
                <a:srgbClr val="ff33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455760" y="1230120"/>
                <a:ext cx="167652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218880" y="102060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214200" y="137772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66680" y="205560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66680" y="240192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4" name=""/>
            <p:cNvSpPr/>
            <p:nvPr/>
          </p:nvSpPr>
          <p:spPr>
            <a:xfrm>
              <a:off x="1298160" y="2400120"/>
              <a:ext cx="8359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31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69800" y="1104840"/>
              <a:ext cx="495360" cy="88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1760" bIns="41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>
            <a:off x="2254320" y="5429160"/>
            <a:ext cx="2123640" cy="45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cnd1, Lgals3, Cspg4, Zo2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Rab20, Enpp1, Sgp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4"/>
          <a:srcRect l="0" t="38179" r="0" b="0"/>
          <a:stretch/>
        </p:blipFill>
        <p:spPr>
          <a:xfrm>
            <a:off x="2209680" y="4622760"/>
            <a:ext cx="2133720" cy="785880"/>
          </a:xfrm>
          <a:prstGeom prst="rect">
            <a:avLst/>
          </a:prstGeom>
          <a:ln w="0">
            <a:noFill/>
          </a:ln>
        </p:spPr>
      </p:pic>
      <p:grpSp>
        <p:nvGrpSpPr>
          <p:cNvPr id="68" name=""/>
          <p:cNvGrpSpPr/>
          <p:nvPr/>
        </p:nvGrpSpPr>
        <p:grpSpPr>
          <a:xfrm>
            <a:off x="162000" y="4608360"/>
            <a:ext cx="1987560" cy="1741680"/>
            <a:chOff x="162000" y="4608360"/>
            <a:chExt cx="1987560" cy="1741680"/>
          </a:xfrm>
        </p:grpSpPr>
        <p:grpSp>
          <p:nvGrpSpPr>
            <p:cNvPr id="69" name=""/>
            <p:cNvGrpSpPr/>
            <p:nvPr/>
          </p:nvGrpSpPr>
          <p:grpSpPr>
            <a:xfrm>
              <a:off x="162000" y="4608360"/>
              <a:ext cx="1987560" cy="1741680"/>
              <a:chOff x="162000" y="4608360"/>
              <a:chExt cx="1987560" cy="1741680"/>
            </a:xfrm>
          </p:grpSpPr>
          <p:pic>
            <p:nvPicPr>
              <p:cNvPr id="70" name="" descr=""/>
              <p:cNvPicPr/>
              <p:nvPr/>
            </p:nvPicPr>
            <p:blipFill>
              <a:blip r:embed="rId5"/>
              <a:srcRect l="73843" t="33790" r="1607" b="33790"/>
              <a:stretch/>
            </p:blipFill>
            <p:spPr>
              <a:xfrm>
                <a:off x="385920" y="4608360"/>
                <a:ext cx="1763640" cy="17416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71" name=""/>
              <p:cNvGrpSpPr/>
              <p:nvPr/>
            </p:nvGrpSpPr>
            <p:grpSpPr>
              <a:xfrm>
                <a:off x="162000" y="4780080"/>
                <a:ext cx="1550520" cy="1416960"/>
                <a:chOff x="162000" y="4780080"/>
                <a:chExt cx="1550520" cy="1416960"/>
              </a:xfrm>
            </p:grpSpPr>
            <p:sp>
              <p:nvSpPr>
                <p:cNvPr id="72" name=""/>
                <p:cNvSpPr/>
                <p:nvPr/>
              </p:nvSpPr>
              <p:spPr>
                <a:xfrm>
                  <a:off x="1327320" y="5433840"/>
                  <a:ext cx="152280" cy="304560"/>
                </a:xfrm>
                <a:prstGeom prst="upArrow">
                  <a:avLst>
                    <a:gd name="adj1" fmla="val 50000"/>
                    <a:gd name="adj2" fmla="val 50000"/>
                  </a:avLst>
                </a:prstGeom>
                <a:solidFill>
                  <a:srgbClr val="ff3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1172160" y="5765760"/>
                  <a:ext cx="540360" cy="304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nl-NL" sz="1400" spc="-1" strike="noStrike">
                      <a:solidFill>
                        <a:srgbClr val="000000"/>
                      </a:solidFill>
                      <a:latin typeface="Arial"/>
                    </a:rPr>
                    <a:t>4-24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182160" y="5051160"/>
                  <a:ext cx="268920" cy="27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333399"/>
                      </a:solidFill>
                      <a:latin typeface="Arial"/>
                    </a:rPr>
                    <a:t>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182160" y="4780080"/>
                  <a:ext cx="268920" cy="27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333399"/>
                      </a:solidFill>
                      <a:latin typeface="Arial"/>
                    </a:rPr>
                    <a:t>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168480" y="5618160"/>
                  <a:ext cx="319320" cy="27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333399"/>
                      </a:solidFill>
                      <a:latin typeface="Arial"/>
                    </a:rPr>
                    <a:t>-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162000" y="5922720"/>
                  <a:ext cx="319320" cy="274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333399"/>
                      </a:solidFill>
                      <a:latin typeface="Arial"/>
                    </a:rPr>
                    <a:t>-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" name=""/>
              <p:cNvSpPr/>
              <p:nvPr/>
            </p:nvSpPr>
            <p:spPr>
              <a:xfrm>
                <a:off x="460440" y="5122800"/>
                <a:ext cx="167328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" name=""/>
            <p:cNvSpPr/>
            <p:nvPr/>
          </p:nvSpPr>
          <p:spPr>
            <a:xfrm>
              <a:off x="482760" y="4736880"/>
              <a:ext cx="495000" cy="88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298160" y="6049800"/>
              <a:ext cx="83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82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"/>
          <p:cNvGrpSpPr/>
          <p:nvPr/>
        </p:nvGrpSpPr>
        <p:grpSpPr>
          <a:xfrm>
            <a:off x="181080" y="2789280"/>
            <a:ext cx="1995480" cy="1741320"/>
            <a:chOff x="181080" y="2789280"/>
            <a:chExt cx="1995480" cy="1741320"/>
          </a:xfrm>
        </p:grpSpPr>
        <p:grpSp>
          <p:nvGrpSpPr>
            <p:cNvPr id="82" name=""/>
            <p:cNvGrpSpPr/>
            <p:nvPr/>
          </p:nvGrpSpPr>
          <p:grpSpPr>
            <a:xfrm>
              <a:off x="181080" y="2789280"/>
              <a:ext cx="1995480" cy="1741320"/>
              <a:chOff x="181080" y="2789280"/>
              <a:chExt cx="1995480" cy="1741320"/>
            </a:xfrm>
          </p:grpSpPr>
          <p:pic>
            <p:nvPicPr>
              <p:cNvPr id="83" name="" descr=""/>
              <p:cNvPicPr/>
              <p:nvPr/>
            </p:nvPicPr>
            <p:blipFill>
              <a:blip r:embed="rId6"/>
              <a:srcRect l="25271" t="33790" r="50449" b="33790"/>
              <a:stretch/>
            </p:blipFill>
            <p:spPr>
              <a:xfrm>
                <a:off x="430200" y="2789280"/>
                <a:ext cx="1746360" cy="1741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4" name=""/>
              <p:cNvSpPr/>
              <p:nvPr/>
            </p:nvSpPr>
            <p:spPr>
              <a:xfrm>
                <a:off x="1076400" y="3779640"/>
                <a:ext cx="48096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2-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192320" y="3457440"/>
                <a:ext cx="154080" cy="304560"/>
              </a:xfrm>
              <a:prstGeom prst="upArrow">
                <a:avLst>
                  <a:gd name="adj1" fmla="val 50000"/>
                  <a:gd name="adj2" fmla="val 49416"/>
                </a:avLst>
              </a:prstGeom>
              <a:solidFill>
                <a:srgbClr val="ff33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71600" y="3144600"/>
                <a:ext cx="167328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28240" y="295560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28240" y="325116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81080" y="377964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181080" y="408456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" name=""/>
            <p:cNvSpPr/>
            <p:nvPr/>
          </p:nvSpPr>
          <p:spPr>
            <a:xfrm>
              <a:off x="1298160" y="4216320"/>
              <a:ext cx="83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87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82760" y="2908080"/>
              <a:ext cx="495000" cy="88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1760" bIns="41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" name=""/>
          <p:cNvSpPr/>
          <p:nvPr/>
        </p:nvSpPr>
        <p:spPr>
          <a:xfrm>
            <a:off x="6745320" y="662040"/>
            <a:ext cx="2230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0.5  1    2    4    6    2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h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424840" y="969840"/>
            <a:ext cx="183600" cy="51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" descr=""/>
          <p:cNvPicPr/>
          <p:nvPr/>
        </p:nvPicPr>
        <p:blipFill>
          <a:blip r:embed="rId7"/>
          <a:srcRect l="0" t="37186" r="0" b="0"/>
          <a:stretch/>
        </p:blipFill>
        <p:spPr>
          <a:xfrm>
            <a:off x="6804000" y="952560"/>
            <a:ext cx="2133720" cy="83808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8"/>
          <a:srcRect l="0" t="41390" r="0" b="0"/>
          <a:stretch/>
        </p:blipFill>
        <p:spPr>
          <a:xfrm>
            <a:off x="6804000" y="2781360"/>
            <a:ext cx="2133720" cy="685800"/>
          </a:xfrm>
          <a:prstGeom prst="rect">
            <a:avLst/>
          </a:prstGeom>
          <a:ln w="0">
            <a:noFill/>
          </a:ln>
        </p:spPr>
      </p:pic>
      <p:sp>
        <p:nvSpPr>
          <p:cNvPr id="97" name=""/>
          <p:cNvSpPr/>
          <p:nvPr/>
        </p:nvSpPr>
        <p:spPr>
          <a:xfrm>
            <a:off x="6904080" y="3533760"/>
            <a:ext cx="1663560" cy="100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HoxA9, Snai2, Sox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Gas1,Osr2, Ppp1r3c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Fzd2, Nedd9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CyclinG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6908760" y="1752480"/>
            <a:ext cx="2006640" cy="82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Gas2, Gas3, Cdkn1b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damts-5, Adamts-1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VegfB, Bmp4, Cd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927680" y="-76320"/>
            <a:ext cx="3606840" cy="99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own-regulated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921360" y="5257800"/>
            <a:ext cx="1752840" cy="45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Fgfr2, Fgf18, Rgs4, Inpp5a, Agtr2, Lama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" descr=""/>
          <p:cNvPicPr/>
          <p:nvPr/>
        </p:nvPicPr>
        <p:blipFill>
          <a:blip r:embed="rId9"/>
          <a:srcRect l="0" t="44682" r="0" b="0"/>
          <a:stretch/>
        </p:blipFill>
        <p:spPr>
          <a:xfrm>
            <a:off x="6804000" y="4606920"/>
            <a:ext cx="2133720" cy="62712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5043600" y="2209680"/>
            <a:ext cx="1673280" cy="0"/>
          </a:xfrm>
          <a:prstGeom prst="line">
            <a:avLst/>
          </a:prstGeom>
          <a:ln w="19080">
            <a:solidFill>
              <a:srgbClr val="333399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" name=""/>
          <p:cNvGrpSpPr/>
          <p:nvPr/>
        </p:nvGrpSpPr>
        <p:grpSpPr>
          <a:xfrm>
            <a:off x="4759200" y="919080"/>
            <a:ext cx="2043000" cy="1835280"/>
            <a:chOff x="4759200" y="919080"/>
            <a:chExt cx="2043000" cy="1835280"/>
          </a:xfrm>
        </p:grpSpPr>
        <p:pic>
          <p:nvPicPr>
            <p:cNvPr id="104" name="" descr=""/>
            <p:cNvPicPr/>
            <p:nvPr/>
          </p:nvPicPr>
          <p:blipFill>
            <a:blip r:embed="rId10"/>
            <a:srcRect l="50272" t="0" r="25448" b="66272"/>
            <a:stretch/>
          </p:blipFill>
          <p:spPr>
            <a:xfrm>
              <a:off x="5032080" y="919080"/>
              <a:ext cx="1770120" cy="183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"/>
            <p:cNvSpPr/>
            <p:nvPr/>
          </p:nvSpPr>
          <p:spPr>
            <a:xfrm>
              <a:off x="5856480" y="2394000"/>
              <a:ext cx="4914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nl-NL" sz="1400" spc="-1" strike="noStrike">
                  <a:solidFill>
                    <a:srgbClr val="000000"/>
                  </a:solidFill>
                  <a:latin typeface="Arial"/>
                </a:rPr>
                <a:t>4-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812840" y="1114560"/>
              <a:ext cx="2689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812840" y="1419120"/>
              <a:ext cx="2689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765320" y="1985760"/>
              <a:ext cx="3193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759200" y="2290680"/>
              <a:ext cx="3193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99"/>
                  </a:solidFill>
                  <a:latin typeface="Arial"/>
                </a:rPr>
                <a:t>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805360" y="2259000"/>
              <a:ext cx="153720" cy="304920"/>
            </a:xfrm>
            <a:prstGeom prst="upArrow">
              <a:avLst>
                <a:gd name="adj1" fmla="val 50000"/>
                <a:gd name="adj2" fmla="val 49590"/>
              </a:avLst>
            </a:prstGeom>
            <a:solidFill>
              <a:srgbClr val="00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063400" y="1020600"/>
              <a:ext cx="8359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82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"/>
          <p:cNvGrpSpPr/>
          <p:nvPr/>
        </p:nvGrpSpPr>
        <p:grpSpPr>
          <a:xfrm>
            <a:off x="4743360" y="4622760"/>
            <a:ext cx="2032200" cy="1752480"/>
            <a:chOff x="4743360" y="4622760"/>
            <a:chExt cx="2032200" cy="1752480"/>
          </a:xfrm>
        </p:grpSpPr>
        <p:grpSp>
          <p:nvGrpSpPr>
            <p:cNvPr id="113" name=""/>
            <p:cNvGrpSpPr/>
            <p:nvPr/>
          </p:nvGrpSpPr>
          <p:grpSpPr>
            <a:xfrm>
              <a:off x="4743360" y="4622760"/>
              <a:ext cx="2032200" cy="1752480"/>
              <a:chOff x="4743360" y="4622760"/>
              <a:chExt cx="2032200" cy="1752480"/>
            </a:xfrm>
          </p:grpSpPr>
          <p:pic>
            <p:nvPicPr>
              <p:cNvPr id="114" name="" descr=""/>
              <p:cNvPicPr/>
              <p:nvPr/>
            </p:nvPicPr>
            <p:blipFill>
              <a:blip r:embed="rId11"/>
              <a:srcRect l="0" t="33790" r="74733" b="33790"/>
              <a:stretch/>
            </p:blipFill>
            <p:spPr>
              <a:xfrm>
                <a:off x="4950000" y="4622760"/>
                <a:ext cx="1825560" cy="1752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5" name=""/>
              <p:cNvSpPr/>
              <p:nvPr/>
            </p:nvSpPr>
            <p:spPr>
              <a:xfrm>
                <a:off x="6113880" y="6054840"/>
                <a:ext cx="54036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4-2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5021280" y="5900760"/>
                <a:ext cx="167328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743360" y="593388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4743360" y="562932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790880" y="478296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790880" y="509580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6058080" y="5945040"/>
                <a:ext cx="153720" cy="304920"/>
              </a:xfrm>
              <a:prstGeom prst="upArrow">
                <a:avLst>
                  <a:gd name="adj1" fmla="val 50000"/>
                  <a:gd name="adj2" fmla="val 49590"/>
                </a:avLst>
              </a:prstGeom>
              <a:solidFill>
                <a:srgbClr val="00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2" name=""/>
            <p:cNvSpPr/>
            <p:nvPr/>
          </p:nvSpPr>
          <p:spPr>
            <a:xfrm>
              <a:off x="5063760" y="4670280"/>
              <a:ext cx="8359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58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3" name=""/>
          <p:cNvGrpSpPr/>
          <p:nvPr/>
        </p:nvGrpSpPr>
        <p:grpSpPr>
          <a:xfrm>
            <a:off x="4746600" y="2747880"/>
            <a:ext cx="2022480" cy="1823760"/>
            <a:chOff x="4746600" y="2747880"/>
            <a:chExt cx="2022480" cy="1823760"/>
          </a:xfrm>
        </p:grpSpPr>
        <p:grpSp>
          <p:nvGrpSpPr>
            <p:cNvPr id="124" name=""/>
            <p:cNvGrpSpPr/>
            <p:nvPr/>
          </p:nvGrpSpPr>
          <p:grpSpPr>
            <a:xfrm>
              <a:off x="4746600" y="2747880"/>
              <a:ext cx="2022480" cy="1823760"/>
              <a:chOff x="4746600" y="2747880"/>
              <a:chExt cx="2022480" cy="1823760"/>
            </a:xfrm>
          </p:grpSpPr>
          <p:pic>
            <p:nvPicPr>
              <p:cNvPr id="125" name="" descr=""/>
              <p:cNvPicPr/>
              <p:nvPr/>
            </p:nvPicPr>
            <p:blipFill>
              <a:blip r:embed="rId12"/>
              <a:srcRect l="74733" t="0" r="1160" b="66272"/>
              <a:stretch/>
            </p:blipFill>
            <p:spPr>
              <a:xfrm>
                <a:off x="5023080" y="2747880"/>
                <a:ext cx="1746000" cy="1823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6" name=""/>
              <p:cNvSpPr/>
              <p:nvPr/>
            </p:nvSpPr>
            <p:spPr>
              <a:xfrm>
                <a:off x="5043600" y="4169880"/>
                <a:ext cx="167328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5860440" y="4230360"/>
                <a:ext cx="4410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nl-NL" sz="1400" spc="-1" strike="noStrike">
                    <a:solidFill>
                      <a:srgbClr val="000000"/>
                    </a:solidFill>
                    <a:latin typeface="Arial"/>
                  </a:rPr>
                  <a:t>2-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5726160" y="4203360"/>
                <a:ext cx="154080" cy="304560"/>
              </a:xfrm>
              <a:prstGeom prst="upArrow">
                <a:avLst>
                  <a:gd name="adj1" fmla="val 50000"/>
                  <a:gd name="adj2" fmla="val 49416"/>
                </a:avLst>
              </a:prstGeom>
              <a:solidFill>
                <a:srgbClr val="00cc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4813200" y="301896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751640" y="382248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746600" y="4111200"/>
                <a:ext cx="3193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813200" y="3323880"/>
                <a:ext cx="268920" cy="274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333399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3" name=""/>
            <p:cNvSpPr/>
            <p:nvPr/>
          </p:nvSpPr>
          <p:spPr>
            <a:xfrm>
              <a:off x="5063760" y="2831760"/>
              <a:ext cx="8359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3399"/>
                  </a:solidFill>
                  <a:latin typeface="Arial"/>
                </a:rPr>
                <a:t>69 gen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" name=""/>
          <p:cNvSpPr/>
          <p:nvPr/>
        </p:nvSpPr>
        <p:spPr>
          <a:xfrm>
            <a:off x="2136600" y="662040"/>
            <a:ext cx="2230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0.5  1    2    4    6    2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nl-NL" sz="1400" spc="-1" strike="noStrike">
                <a:solidFill>
                  <a:srgbClr val="000000"/>
                </a:solidFill>
                <a:latin typeface="Arial"/>
              </a:rPr>
              <a:t>h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533520" y="-152280"/>
            <a:ext cx="2895480" cy="99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elayed genes</a:t>
            </a: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553080" y="6400800"/>
            <a:ext cx="2590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Arial"/>
              </a:rPr>
              <a:t>Additional file 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11T09:40:13Z</dcterms:created>
  <dc:creator>w.moolenaar</dc:creator>
  <dc:description/>
  <dc:language>en-US</dc:language>
  <cp:lastModifiedBy>w.moolenaar</cp:lastModifiedBy>
  <dcterms:modified xsi:type="dcterms:W3CDTF">2008-08-11T09:40:44Z</dcterms:modified>
  <cp:revision>1</cp:revision>
  <dc:subject/>
  <dc:title>Slide 1</dc:title>
</cp:coreProperties>
</file>